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sldIdLst>
    <p:sldId id="256" r:id="rId2"/>
  </p:sldIdLst>
  <p:sldSz cx="15240000" cy="8572500"/>
  <p:notesSz cx="6858000" cy="9144000"/>
  <p:embeddedFontLst>
    <p:embeddedFont>
      <p:font typeface="Canva Sans" panose="020B0503030501040103" pitchFamily="34" charset="0"/>
      <p:regular r:id="rId3"/>
    </p:embeddedFont>
    <p:embeddedFont>
      <p:font typeface="Canva Sans Bold" panose="020B0803030501040103" pitchFamily="34" charset="0"/>
      <p:regular r:id="rId4"/>
      <p:bold r:id="rId5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 autoAdjust="0"/>
    <p:restoredTop sz="94607" autoAdjust="0"/>
  </p:normalViewPr>
  <p:slideViewPr>
    <p:cSldViewPr>
      <p:cViewPr varScale="1">
        <p:scale>
          <a:sx n="85" d="100"/>
          <a:sy n="85" d="100"/>
        </p:scale>
        <p:origin x="776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font" Target="fonts/font1.fntdata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font" Target="fonts/font3.fntdata"/><Relationship Id="rId4" Type="http://schemas.openxmlformats.org/officeDocument/2006/relationships/font" Target="fonts/font2.fntdata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2"/>
          <p:cNvSpPr/>
          <p:nvPr/>
        </p:nvSpPr>
        <p:spPr>
          <a:xfrm>
            <a:off x="0" y="7715250"/>
            <a:ext cx="9417716" cy="835822"/>
          </a:xfrm>
          <a:custGeom>
            <a:avLst/>
            <a:gdLst/>
            <a:ahLst/>
            <a:cxnLst/>
            <a:rect l="l" t="t" r="r" b="b"/>
            <a:pathLst>
              <a:path w="9417716" h="835822">
                <a:moveTo>
                  <a:pt x="0" y="0"/>
                </a:moveTo>
                <a:lnTo>
                  <a:pt x="9417716" y="0"/>
                </a:lnTo>
                <a:lnTo>
                  <a:pt x="9417716" y="835822"/>
                </a:lnTo>
                <a:lnTo>
                  <a:pt x="0" y="835822"/>
                </a:lnTo>
                <a:lnTo>
                  <a:pt x="0" y="0"/>
                </a:lnTo>
                <a:close/>
              </a:path>
            </a:pathLst>
          </a:custGeom>
          <a:blipFill>
            <a:blip r:embed="rId2"/>
            <a:stretch>
              <a:fillRect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3" name="Freeform 3"/>
          <p:cNvSpPr/>
          <p:nvPr/>
        </p:nvSpPr>
        <p:spPr>
          <a:xfrm>
            <a:off x="11241121" y="7786471"/>
            <a:ext cx="3863119" cy="693380"/>
          </a:xfrm>
          <a:custGeom>
            <a:avLst/>
            <a:gdLst/>
            <a:ahLst/>
            <a:cxnLst/>
            <a:rect l="l" t="t" r="r" b="b"/>
            <a:pathLst>
              <a:path w="3863119" h="693380">
                <a:moveTo>
                  <a:pt x="0" y="0"/>
                </a:moveTo>
                <a:lnTo>
                  <a:pt x="3863119" y="0"/>
                </a:lnTo>
                <a:lnTo>
                  <a:pt x="3863119" y="693380"/>
                </a:lnTo>
                <a:lnTo>
                  <a:pt x="0" y="693380"/>
                </a:lnTo>
                <a:lnTo>
                  <a:pt x="0" y="0"/>
                </a:lnTo>
                <a:close/>
              </a:path>
            </a:pathLst>
          </a:custGeom>
          <a:blipFill>
            <a:blip r:embed="rId3"/>
            <a:stretch>
              <a:fillRect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4" name="Freeform 4"/>
          <p:cNvSpPr/>
          <p:nvPr/>
        </p:nvSpPr>
        <p:spPr>
          <a:xfrm>
            <a:off x="0" y="1548142"/>
            <a:ext cx="15240000" cy="5943441"/>
          </a:xfrm>
          <a:custGeom>
            <a:avLst/>
            <a:gdLst/>
            <a:ahLst/>
            <a:cxnLst/>
            <a:rect l="l" t="t" r="r" b="b"/>
            <a:pathLst>
              <a:path w="15240000" h="5943441">
                <a:moveTo>
                  <a:pt x="0" y="0"/>
                </a:moveTo>
                <a:lnTo>
                  <a:pt x="15240000" y="0"/>
                </a:lnTo>
                <a:lnTo>
                  <a:pt x="15240000" y="5943441"/>
                </a:lnTo>
                <a:lnTo>
                  <a:pt x="0" y="5943441"/>
                </a:lnTo>
                <a:lnTo>
                  <a:pt x="0" y="0"/>
                </a:lnTo>
                <a:close/>
              </a:path>
            </a:pathLst>
          </a:custGeom>
          <a:blipFill>
            <a:blip r:embed="rId4"/>
            <a:stretch>
              <a:fillRect t="-10607" b="-10870"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5" name="Freeform 5"/>
          <p:cNvSpPr/>
          <p:nvPr/>
        </p:nvSpPr>
        <p:spPr>
          <a:xfrm>
            <a:off x="0" y="-40263"/>
            <a:ext cx="15240000" cy="1119775"/>
          </a:xfrm>
          <a:custGeom>
            <a:avLst/>
            <a:gdLst/>
            <a:ahLst/>
            <a:cxnLst/>
            <a:rect l="l" t="t" r="r" b="b"/>
            <a:pathLst>
              <a:path w="15240000" h="1119775">
                <a:moveTo>
                  <a:pt x="0" y="0"/>
                </a:moveTo>
                <a:lnTo>
                  <a:pt x="15240000" y="0"/>
                </a:lnTo>
                <a:lnTo>
                  <a:pt x="15240000" y="1119775"/>
                </a:lnTo>
                <a:lnTo>
                  <a:pt x="0" y="1119775"/>
                </a:lnTo>
                <a:lnTo>
                  <a:pt x="0" y="0"/>
                </a:lnTo>
                <a:close/>
              </a:path>
            </a:pathLst>
          </a:custGeom>
          <a:blipFill>
            <a:blip r:embed="rId5"/>
            <a:stretch>
              <a:fillRect l="-3871" t="-13643" r="-3871"/>
            </a:stretch>
          </a:blipFill>
        </p:spPr>
        <p:txBody>
          <a:bodyPr/>
          <a:lstStyle/>
          <a:p>
            <a:endParaRPr lang="en-US"/>
          </a:p>
        </p:txBody>
      </p:sp>
      <p:grpSp>
        <p:nvGrpSpPr>
          <p:cNvPr id="6" name="Group 6"/>
          <p:cNvGrpSpPr/>
          <p:nvPr/>
        </p:nvGrpSpPr>
        <p:grpSpPr>
          <a:xfrm>
            <a:off x="12625619" y="2837668"/>
            <a:ext cx="2478621" cy="4112101"/>
            <a:chOff x="0" y="0"/>
            <a:chExt cx="783367" cy="1299627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783367" cy="1299627"/>
            </a:xfrm>
            <a:custGeom>
              <a:avLst/>
              <a:gdLst/>
              <a:ahLst/>
              <a:cxnLst/>
              <a:rect l="l" t="t" r="r" b="b"/>
              <a:pathLst>
                <a:path w="783367" h="1299627">
                  <a:moveTo>
                    <a:pt x="0" y="0"/>
                  </a:moveTo>
                  <a:lnTo>
                    <a:pt x="783367" y="0"/>
                  </a:lnTo>
                  <a:lnTo>
                    <a:pt x="783367" y="1299627"/>
                  </a:lnTo>
                  <a:lnTo>
                    <a:pt x="0" y="1299627"/>
                  </a:lnTo>
                  <a:close/>
                </a:path>
              </a:pathLst>
            </a:custGeom>
            <a:solidFill>
              <a:srgbClr val="000000">
                <a:alpha val="0"/>
              </a:srgbClr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8" name="TextBox 8"/>
            <p:cNvSpPr txBox="1"/>
            <p:nvPr/>
          </p:nvSpPr>
          <p:spPr>
            <a:xfrm>
              <a:off x="0" y="-47625"/>
              <a:ext cx="783367" cy="1347252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800"/>
                </a:lnSpc>
              </a:pPr>
              <a:endParaRPr/>
            </a:p>
          </p:txBody>
        </p:sp>
      </p:grpSp>
      <p:sp>
        <p:nvSpPr>
          <p:cNvPr id="9" name="TextBox 9"/>
          <p:cNvSpPr txBox="1"/>
          <p:nvPr/>
        </p:nvSpPr>
        <p:spPr>
          <a:xfrm>
            <a:off x="428625" y="100525"/>
            <a:ext cx="14382750" cy="83820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3359"/>
              </a:lnSpc>
            </a:pPr>
            <a:r>
              <a:rPr lang="en-US" sz="2799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Improving uptake of lung cancer screening – an observational study on the impact of timed appointments and reminders</a:t>
            </a:r>
          </a:p>
        </p:txBody>
      </p:sp>
      <p:sp>
        <p:nvSpPr>
          <p:cNvPr id="10" name="TextBox 10"/>
          <p:cNvSpPr txBox="1"/>
          <p:nvPr/>
        </p:nvSpPr>
        <p:spPr>
          <a:xfrm>
            <a:off x="-38262" y="1150950"/>
            <a:ext cx="15316525" cy="29718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519"/>
              </a:lnSpc>
              <a:spcBef>
                <a:spcPct val="0"/>
              </a:spcBef>
            </a:pPr>
            <a:r>
              <a:rPr lang="en-US" sz="1799">
                <a:solidFill>
                  <a:srgbClr val="000000"/>
                </a:solidFill>
                <a:latin typeface="Canva Sans"/>
                <a:ea typeface="Canva Sans"/>
                <a:cs typeface="Canva Sans"/>
                <a:sym typeface="Canva Sans"/>
              </a:rPr>
              <a:t>A Bhamani, SB Naidu, et al. Thorax 2024. DOI: 10.1136/thorax-2024-222433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25632" y="1639502"/>
            <a:ext cx="14988735" cy="5760720"/>
            <a:chOff x="0" y="0"/>
            <a:chExt cx="19984980" cy="7680960"/>
          </a:xfrm>
        </p:grpSpPr>
        <p:sp>
          <p:nvSpPr>
            <p:cNvPr id="12" name="Freeform 12"/>
            <p:cNvSpPr/>
            <p:nvPr/>
          </p:nvSpPr>
          <p:spPr>
            <a:xfrm>
              <a:off x="6720970" y="0"/>
              <a:ext cx="6543040" cy="7649875"/>
            </a:xfrm>
            <a:custGeom>
              <a:avLst/>
              <a:gdLst/>
              <a:ahLst/>
              <a:cxnLst/>
              <a:rect l="l" t="t" r="r" b="b"/>
              <a:pathLst>
                <a:path w="6543040" h="7649875">
                  <a:moveTo>
                    <a:pt x="0" y="0"/>
                  </a:moveTo>
                  <a:lnTo>
                    <a:pt x="6543040" y="0"/>
                  </a:lnTo>
                  <a:lnTo>
                    <a:pt x="6543040" y="7649875"/>
                  </a:lnTo>
                  <a:lnTo>
                    <a:pt x="0" y="7649875"/>
                  </a:lnTo>
                  <a:lnTo>
                    <a:pt x="0" y="0"/>
                  </a:lnTo>
                  <a:close/>
                </a:path>
              </a:pathLst>
            </a:custGeom>
            <a:blipFill>
              <a:blip r:embed="rId6"/>
              <a:stretch>
                <a:fillRect t="-8976" b="-11696"/>
              </a:stretch>
            </a:blipFill>
          </p:spPr>
          <p:txBody>
            <a:bodyPr/>
            <a:lstStyle/>
            <a:p>
              <a:endParaRPr lang="en-US"/>
            </a:p>
          </p:txBody>
        </p:sp>
        <p:grpSp>
          <p:nvGrpSpPr>
            <p:cNvPr id="13" name="Group 13"/>
            <p:cNvGrpSpPr/>
            <p:nvPr/>
          </p:nvGrpSpPr>
          <p:grpSpPr>
            <a:xfrm>
              <a:off x="6720970" y="0"/>
              <a:ext cx="6543040" cy="1047496"/>
              <a:chOff x="0" y="0"/>
              <a:chExt cx="1550943" cy="248295"/>
            </a:xfrm>
          </p:grpSpPr>
          <p:sp>
            <p:nvSpPr>
              <p:cNvPr id="14" name="Freeform 14"/>
              <p:cNvSpPr/>
              <p:nvPr/>
            </p:nvSpPr>
            <p:spPr>
              <a:xfrm>
                <a:off x="0" y="0"/>
                <a:ext cx="1550943" cy="248295"/>
              </a:xfrm>
              <a:custGeom>
                <a:avLst/>
                <a:gdLst/>
                <a:ahLst/>
                <a:cxnLst/>
                <a:rect l="l" t="t" r="r" b="b"/>
                <a:pathLst>
                  <a:path w="1550943" h="248295">
                    <a:moveTo>
                      <a:pt x="0" y="0"/>
                    </a:moveTo>
                    <a:lnTo>
                      <a:pt x="1550943" y="0"/>
                    </a:lnTo>
                    <a:lnTo>
                      <a:pt x="1550943" y="248295"/>
                    </a:lnTo>
                    <a:lnTo>
                      <a:pt x="0" y="248295"/>
                    </a:lnTo>
                    <a:close/>
                  </a:path>
                </a:pathLst>
              </a:custGeom>
              <a:solidFill>
                <a:srgbClr val="00B0F0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" name="TextBox 15"/>
              <p:cNvSpPr txBox="1"/>
              <p:nvPr/>
            </p:nvSpPr>
            <p:spPr>
              <a:xfrm>
                <a:off x="0" y="38100"/>
                <a:ext cx="1550943" cy="21019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200"/>
                  </a:lnSpc>
                </a:pPr>
                <a:r>
                  <a:rPr lang="en-US" sz="2200" b="1">
                    <a:solidFill>
                      <a:srgbClr val="FFFFFF"/>
                    </a:solidFill>
                    <a:latin typeface="Canva Sans Bold"/>
                    <a:ea typeface="Canva Sans Bold"/>
                    <a:cs typeface="Canva Sans Bold"/>
                    <a:sym typeface="Canva Sans Bold"/>
                  </a:rPr>
                  <a:t>Timed appointments </a:t>
                </a:r>
              </a:p>
              <a:p>
                <a:pPr algn="ctr">
                  <a:lnSpc>
                    <a:spcPts val="2200"/>
                  </a:lnSpc>
                </a:pPr>
                <a:r>
                  <a:rPr lang="en-US" sz="2200" b="1">
                    <a:solidFill>
                      <a:srgbClr val="FFFFFF"/>
                    </a:solidFill>
                    <a:latin typeface="Canva Sans Bold"/>
                    <a:ea typeface="Canva Sans Bold"/>
                    <a:cs typeface="Canva Sans Bold"/>
                    <a:sym typeface="Canva Sans Bold"/>
                  </a:rPr>
                  <a:t>improve uptake</a:t>
                </a:r>
              </a:p>
            </p:txBody>
          </p:sp>
        </p:grpSp>
        <p:grpSp>
          <p:nvGrpSpPr>
            <p:cNvPr id="16" name="Group 16"/>
            <p:cNvGrpSpPr/>
            <p:nvPr/>
          </p:nvGrpSpPr>
          <p:grpSpPr>
            <a:xfrm>
              <a:off x="8040931" y="3740917"/>
              <a:ext cx="623348" cy="623348"/>
              <a:chOff x="0" y="0"/>
              <a:chExt cx="812800" cy="812800"/>
            </a:xfrm>
          </p:grpSpPr>
          <p:sp>
            <p:nvSpPr>
              <p:cNvPr id="17" name="Freeform 17"/>
              <p:cNvSpPr/>
              <p:nvPr/>
            </p:nvSpPr>
            <p:spPr>
              <a:xfrm>
                <a:off x="0" y="0"/>
                <a:ext cx="812800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812800" h="812800">
                    <a:moveTo>
                      <a:pt x="406400" y="812800"/>
                    </a:moveTo>
                    <a:lnTo>
                      <a:pt x="0" y="406400"/>
                    </a:lnTo>
                    <a:lnTo>
                      <a:pt x="203200" y="406400"/>
                    </a:lnTo>
                    <a:lnTo>
                      <a:pt x="203200" y="0"/>
                    </a:lnTo>
                    <a:lnTo>
                      <a:pt x="609600" y="0"/>
                    </a:lnTo>
                    <a:lnTo>
                      <a:pt x="609600" y="406400"/>
                    </a:lnTo>
                    <a:lnTo>
                      <a:pt x="812800" y="406400"/>
                    </a:lnTo>
                    <a:lnTo>
                      <a:pt x="406400" y="812800"/>
                    </a:lnTo>
                    <a:close/>
                  </a:path>
                </a:pathLst>
              </a:custGeom>
              <a:solidFill>
                <a:srgbClr val="07252B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" name="TextBox 18"/>
              <p:cNvSpPr txBox="1"/>
              <p:nvPr/>
            </p:nvSpPr>
            <p:spPr>
              <a:xfrm>
                <a:off x="203200" y="-47625"/>
                <a:ext cx="406400" cy="75882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endParaRPr/>
              </a:p>
            </p:txBody>
          </p:sp>
        </p:grpSp>
        <p:grpSp>
          <p:nvGrpSpPr>
            <p:cNvPr id="19" name="Group 19"/>
            <p:cNvGrpSpPr/>
            <p:nvPr/>
          </p:nvGrpSpPr>
          <p:grpSpPr>
            <a:xfrm>
              <a:off x="6855911" y="4556338"/>
              <a:ext cx="2993390" cy="2993390"/>
              <a:chOff x="0" y="0"/>
              <a:chExt cx="779564" cy="779564"/>
            </a:xfrm>
          </p:grpSpPr>
          <p:sp>
            <p:nvSpPr>
              <p:cNvPr id="20" name="Freeform 20"/>
              <p:cNvSpPr/>
              <p:nvPr/>
            </p:nvSpPr>
            <p:spPr>
              <a:xfrm>
                <a:off x="0" y="0"/>
                <a:ext cx="779564" cy="779564"/>
              </a:xfrm>
              <a:custGeom>
                <a:avLst/>
                <a:gdLst/>
                <a:ahLst/>
                <a:cxnLst/>
                <a:rect l="l" t="t" r="r" b="b"/>
                <a:pathLst>
                  <a:path w="779564" h="779564">
                    <a:moveTo>
                      <a:pt x="389782" y="0"/>
                    </a:moveTo>
                    <a:cubicBezTo>
                      <a:pt x="174511" y="0"/>
                      <a:pt x="0" y="174511"/>
                      <a:pt x="0" y="389782"/>
                    </a:cubicBezTo>
                    <a:cubicBezTo>
                      <a:pt x="0" y="605053"/>
                      <a:pt x="174511" y="779564"/>
                      <a:pt x="389782" y="779564"/>
                    </a:cubicBezTo>
                    <a:cubicBezTo>
                      <a:pt x="605053" y="779564"/>
                      <a:pt x="779564" y="605053"/>
                      <a:pt x="779564" y="389782"/>
                    </a:cubicBezTo>
                    <a:cubicBezTo>
                      <a:pt x="779564" y="174511"/>
                      <a:pt x="605053" y="0"/>
                      <a:pt x="389782" y="0"/>
                    </a:cubicBezTo>
                    <a:close/>
                  </a:path>
                </a:pathLst>
              </a:custGeom>
              <a:solidFill>
                <a:srgbClr val="F65958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" name="TextBox 21"/>
              <p:cNvSpPr txBox="1"/>
              <p:nvPr/>
            </p:nvSpPr>
            <p:spPr>
              <a:xfrm>
                <a:off x="73084" y="25459"/>
                <a:ext cx="633396" cy="681021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r>
                  <a:rPr lang="en-US" sz="1900" dirty="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Timed appointments 53.0%</a:t>
                </a:r>
              </a:p>
            </p:txBody>
          </p:sp>
        </p:grpSp>
        <p:sp>
          <p:nvSpPr>
            <p:cNvPr id="22" name="TextBox 22"/>
            <p:cNvSpPr txBox="1"/>
            <p:nvPr/>
          </p:nvSpPr>
          <p:spPr>
            <a:xfrm>
              <a:off x="9949030" y="5635838"/>
              <a:ext cx="3048000" cy="805815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ctr">
                <a:lnSpc>
                  <a:spcPts val="2520"/>
                </a:lnSpc>
                <a:spcBef>
                  <a:spcPct val="0"/>
                </a:spcBef>
              </a:pPr>
              <a:r>
                <a:rPr lang="en-US" sz="180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Initial uptake n=17,274/32,593</a:t>
              </a:r>
            </a:p>
          </p:txBody>
        </p:sp>
        <p:sp>
          <p:nvSpPr>
            <p:cNvPr id="23" name="TextBox 23"/>
            <p:cNvSpPr txBox="1"/>
            <p:nvPr/>
          </p:nvSpPr>
          <p:spPr>
            <a:xfrm>
              <a:off x="9949030" y="1979725"/>
              <a:ext cx="3048000" cy="805815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ctr">
                <a:lnSpc>
                  <a:spcPts val="2520"/>
                </a:lnSpc>
              </a:pPr>
              <a:r>
                <a:rPr lang="en-US" sz="180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Initial uptake </a:t>
              </a:r>
            </a:p>
            <a:p>
              <a:pPr algn="ctr">
                <a:lnSpc>
                  <a:spcPts val="2520"/>
                </a:lnSpc>
                <a:spcBef>
                  <a:spcPct val="0"/>
                </a:spcBef>
              </a:pPr>
              <a:r>
                <a:rPr lang="en-US" sz="180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n=10,246/34,371</a:t>
              </a:r>
            </a:p>
          </p:txBody>
        </p:sp>
        <p:grpSp>
          <p:nvGrpSpPr>
            <p:cNvPr id="24" name="Group 24"/>
            <p:cNvGrpSpPr/>
            <p:nvPr/>
          </p:nvGrpSpPr>
          <p:grpSpPr>
            <a:xfrm>
              <a:off x="7200681" y="1244995"/>
              <a:ext cx="2303849" cy="2303849"/>
              <a:chOff x="0" y="0"/>
              <a:chExt cx="812800" cy="812800"/>
            </a:xfrm>
          </p:grpSpPr>
          <p:sp>
            <p:nvSpPr>
              <p:cNvPr id="25" name="Freeform 25"/>
              <p:cNvSpPr/>
              <p:nvPr/>
            </p:nvSpPr>
            <p:spPr>
              <a:xfrm>
                <a:off x="0" y="0"/>
                <a:ext cx="812800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812800" h="812800">
                    <a:moveTo>
                      <a:pt x="406400" y="0"/>
                    </a:moveTo>
                    <a:cubicBezTo>
                      <a:pt x="181951" y="0"/>
                      <a:pt x="0" y="181951"/>
                      <a:pt x="0" y="406400"/>
                    </a:cubicBezTo>
                    <a:cubicBezTo>
                      <a:pt x="0" y="630849"/>
                      <a:pt x="181951" y="812800"/>
                      <a:pt x="406400" y="812800"/>
                    </a:cubicBezTo>
                    <a:cubicBezTo>
                      <a:pt x="630849" y="812800"/>
                      <a:pt x="812800" y="630849"/>
                      <a:pt x="812800" y="406400"/>
                    </a:cubicBezTo>
                    <a:cubicBezTo>
                      <a:pt x="812800" y="181951"/>
                      <a:pt x="630849" y="0"/>
                      <a:pt x="406400" y="0"/>
                    </a:cubicBezTo>
                    <a:close/>
                  </a:path>
                </a:pathLst>
              </a:custGeom>
              <a:solidFill>
                <a:srgbClr val="FD9174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" name="TextBox 26"/>
              <p:cNvSpPr txBox="1"/>
              <p:nvPr/>
            </p:nvSpPr>
            <p:spPr>
              <a:xfrm>
                <a:off x="76200" y="28575"/>
                <a:ext cx="660400" cy="70802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endParaRPr/>
              </a:p>
            </p:txBody>
          </p:sp>
        </p:grpSp>
        <p:sp>
          <p:nvSpPr>
            <p:cNvPr id="27" name="TextBox 27"/>
            <p:cNvSpPr txBox="1"/>
            <p:nvPr/>
          </p:nvSpPr>
          <p:spPr>
            <a:xfrm>
              <a:off x="7210865" y="1678312"/>
              <a:ext cx="2283481" cy="138959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ctr">
                <a:lnSpc>
                  <a:spcPts val="2800"/>
                </a:lnSpc>
                <a:spcBef>
                  <a:spcPct val="0"/>
                </a:spcBef>
              </a:pPr>
              <a:r>
                <a:rPr lang="en-US" sz="1900" dirty="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Open invitations 29.8%</a:t>
              </a:r>
            </a:p>
          </p:txBody>
        </p:sp>
        <p:sp>
          <p:nvSpPr>
            <p:cNvPr id="28" name="Freeform 28"/>
            <p:cNvSpPr/>
            <p:nvPr/>
          </p:nvSpPr>
          <p:spPr>
            <a:xfrm>
              <a:off x="13441940" y="30782"/>
              <a:ext cx="6543040" cy="7649875"/>
            </a:xfrm>
            <a:custGeom>
              <a:avLst/>
              <a:gdLst/>
              <a:ahLst/>
              <a:cxnLst/>
              <a:rect l="l" t="t" r="r" b="b"/>
              <a:pathLst>
                <a:path w="6543040" h="7649875">
                  <a:moveTo>
                    <a:pt x="0" y="0"/>
                  </a:moveTo>
                  <a:lnTo>
                    <a:pt x="6543040" y="0"/>
                  </a:lnTo>
                  <a:lnTo>
                    <a:pt x="6543040" y="7649876"/>
                  </a:lnTo>
                  <a:lnTo>
                    <a:pt x="0" y="7649876"/>
                  </a:lnTo>
                  <a:lnTo>
                    <a:pt x="0" y="0"/>
                  </a:lnTo>
                  <a:close/>
                </a:path>
              </a:pathLst>
            </a:custGeom>
            <a:blipFill>
              <a:blip r:embed="rId6"/>
              <a:stretch>
                <a:fillRect t="-8976" b="-11696"/>
              </a:stretch>
            </a:blipFill>
          </p:spPr>
          <p:txBody>
            <a:bodyPr/>
            <a:lstStyle/>
            <a:p>
              <a:endParaRPr lang="en-US"/>
            </a:p>
          </p:txBody>
        </p:sp>
        <p:grpSp>
          <p:nvGrpSpPr>
            <p:cNvPr id="29" name="Group 29"/>
            <p:cNvGrpSpPr/>
            <p:nvPr/>
          </p:nvGrpSpPr>
          <p:grpSpPr>
            <a:xfrm>
              <a:off x="13467388" y="30782"/>
              <a:ext cx="6517592" cy="1047496"/>
              <a:chOff x="0" y="0"/>
              <a:chExt cx="1544911" cy="248295"/>
            </a:xfrm>
          </p:grpSpPr>
          <p:sp>
            <p:nvSpPr>
              <p:cNvPr id="30" name="Freeform 30"/>
              <p:cNvSpPr/>
              <p:nvPr/>
            </p:nvSpPr>
            <p:spPr>
              <a:xfrm>
                <a:off x="0" y="0"/>
                <a:ext cx="1544911" cy="248295"/>
              </a:xfrm>
              <a:custGeom>
                <a:avLst/>
                <a:gdLst/>
                <a:ahLst/>
                <a:cxnLst/>
                <a:rect l="l" t="t" r="r" b="b"/>
                <a:pathLst>
                  <a:path w="1544911" h="248295">
                    <a:moveTo>
                      <a:pt x="0" y="0"/>
                    </a:moveTo>
                    <a:lnTo>
                      <a:pt x="1544911" y="0"/>
                    </a:lnTo>
                    <a:lnTo>
                      <a:pt x="1544911" y="248295"/>
                    </a:lnTo>
                    <a:lnTo>
                      <a:pt x="0" y="248295"/>
                    </a:lnTo>
                    <a:close/>
                  </a:path>
                </a:pathLst>
              </a:custGeom>
              <a:solidFill>
                <a:srgbClr val="00B0F0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1" name="TextBox 31"/>
              <p:cNvSpPr txBox="1"/>
              <p:nvPr/>
            </p:nvSpPr>
            <p:spPr>
              <a:xfrm>
                <a:off x="0" y="38100"/>
                <a:ext cx="1544911" cy="21019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200"/>
                  </a:lnSpc>
                </a:pPr>
                <a:r>
                  <a:rPr lang="en-US" sz="2200" b="1">
                    <a:solidFill>
                      <a:srgbClr val="FFFFFF"/>
                    </a:solidFill>
                    <a:latin typeface="Canva Sans Bold"/>
                    <a:ea typeface="Canva Sans Bold"/>
                    <a:cs typeface="Canva Sans Bold"/>
                    <a:sym typeface="Canva Sans Bold"/>
                  </a:rPr>
                  <a:t>Reminders increase uptake amongst initial non-responders</a:t>
                </a:r>
              </a:p>
            </p:txBody>
          </p:sp>
        </p:grpSp>
        <p:grpSp>
          <p:nvGrpSpPr>
            <p:cNvPr id="32" name="Group 32"/>
            <p:cNvGrpSpPr/>
            <p:nvPr/>
          </p:nvGrpSpPr>
          <p:grpSpPr>
            <a:xfrm>
              <a:off x="14769847" y="3741014"/>
              <a:ext cx="623348" cy="623348"/>
              <a:chOff x="0" y="0"/>
              <a:chExt cx="812800" cy="812800"/>
            </a:xfrm>
          </p:grpSpPr>
          <p:sp>
            <p:nvSpPr>
              <p:cNvPr id="33" name="Freeform 33"/>
              <p:cNvSpPr/>
              <p:nvPr/>
            </p:nvSpPr>
            <p:spPr>
              <a:xfrm>
                <a:off x="0" y="0"/>
                <a:ext cx="812800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812800" h="812800">
                    <a:moveTo>
                      <a:pt x="406400" y="812800"/>
                    </a:moveTo>
                    <a:lnTo>
                      <a:pt x="0" y="406400"/>
                    </a:lnTo>
                    <a:lnTo>
                      <a:pt x="203200" y="406400"/>
                    </a:lnTo>
                    <a:lnTo>
                      <a:pt x="203200" y="0"/>
                    </a:lnTo>
                    <a:lnTo>
                      <a:pt x="609600" y="0"/>
                    </a:lnTo>
                    <a:lnTo>
                      <a:pt x="609600" y="406400"/>
                    </a:lnTo>
                    <a:lnTo>
                      <a:pt x="812800" y="406400"/>
                    </a:lnTo>
                    <a:lnTo>
                      <a:pt x="406400" y="812800"/>
                    </a:lnTo>
                    <a:close/>
                  </a:path>
                </a:pathLst>
              </a:custGeom>
              <a:solidFill>
                <a:srgbClr val="07252B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4" name="TextBox 34"/>
              <p:cNvSpPr txBox="1"/>
              <p:nvPr/>
            </p:nvSpPr>
            <p:spPr>
              <a:xfrm>
                <a:off x="203200" y="-47625"/>
                <a:ext cx="406400" cy="75882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endParaRPr/>
              </a:p>
            </p:txBody>
          </p:sp>
        </p:grpSp>
        <p:grpSp>
          <p:nvGrpSpPr>
            <p:cNvPr id="35" name="Group 35"/>
            <p:cNvGrpSpPr/>
            <p:nvPr/>
          </p:nvGrpSpPr>
          <p:grpSpPr>
            <a:xfrm>
              <a:off x="13584923" y="4556532"/>
              <a:ext cx="2993196" cy="2993196"/>
              <a:chOff x="0" y="0"/>
              <a:chExt cx="812800" cy="812800"/>
            </a:xfrm>
          </p:grpSpPr>
          <p:sp>
            <p:nvSpPr>
              <p:cNvPr id="36" name="Freeform 36"/>
              <p:cNvSpPr/>
              <p:nvPr/>
            </p:nvSpPr>
            <p:spPr>
              <a:xfrm>
                <a:off x="0" y="0"/>
                <a:ext cx="812800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812800" h="812800">
                    <a:moveTo>
                      <a:pt x="406400" y="0"/>
                    </a:moveTo>
                    <a:cubicBezTo>
                      <a:pt x="181951" y="0"/>
                      <a:pt x="0" y="181951"/>
                      <a:pt x="0" y="406400"/>
                    </a:cubicBezTo>
                    <a:cubicBezTo>
                      <a:pt x="0" y="630849"/>
                      <a:pt x="181951" y="812800"/>
                      <a:pt x="406400" y="812800"/>
                    </a:cubicBezTo>
                    <a:cubicBezTo>
                      <a:pt x="630849" y="812800"/>
                      <a:pt x="812800" y="630849"/>
                      <a:pt x="812800" y="406400"/>
                    </a:cubicBezTo>
                    <a:cubicBezTo>
                      <a:pt x="812800" y="181951"/>
                      <a:pt x="630849" y="0"/>
                      <a:pt x="406400" y="0"/>
                    </a:cubicBezTo>
                    <a:close/>
                  </a:path>
                </a:pathLst>
              </a:custGeom>
              <a:solidFill>
                <a:srgbClr val="FF9B42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7" name="TextBox 37"/>
              <p:cNvSpPr txBox="1"/>
              <p:nvPr/>
            </p:nvSpPr>
            <p:spPr>
              <a:xfrm>
                <a:off x="76200" y="28575"/>
                <a:ext cx="660400" cy="70802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r>
                  <a:rPr lang="en-US" sz="1900" dirty="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17.5% responded to reminder</a:t>
                </a:r>
              </a:p>
            </p:txBody>
          </p:sp>
        </p:grpSp>
        <p:sp>
          <p:nvSpPr>
            <p:cNvPr id="38" name="TextBox 38"/>
            <p:cNvSpPr txBox="1"/>
            <p:nvPr/>
          </p:nvSpPr>
          <p:spPr>
            <a:xfrm>
              <a:off x="16751584" y="2286175"/>
              <a:ext cx="3048000" cy="4158615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ctr">
                <a:lnSpc>
                  <a:spcPts val="2520"/>
                </a:lnSpc>
              </a:pPr>
              <a:r>
                <a:rPr lang="en-US" sz="180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Characteristics of people more likely to respond to reminders:</a:t>
              </a:r>
            </a:p>
            <a:p>
              <a:pPr algn="ctr">
                <a:lnSpc>
                  <a:spcPts val="2520"/>
                </a:lnSpc>
              </a:pPr>
              <a:endParaRPr lang="en-US" sz="1800">
                <a:solidFill>
                  <a:srgbClr val="000000"/>
                </a:solidFill>
                <a:latin typeface="Canva Sans"/>
                <a:ea typeface="Canva Sans"/>
                <a:cs typeface="Canva Sans"/>
                <a:sym typeface="Canva Sans"/>
              </a:endParaRPr>
            </a:p>
            <a:p>
              <a:pPr marL="388622" lvl="1" indent="-194311" algn="l">
                <a:lnSpc>
                  <a:spcPts val="2520"/>
                </a:lnSpc>
                <a:buFont typeface="Arial"/>
                <a:buChar char="•"/>
              </a:pPr>
              <a:r>
                <a:rPr lang="en-US" sz="180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Black ethnicity </a:t>
              </a:r>
            </a:p>
            <a:p>
              <a:pPr marL="388622" lvl="1" indent="-194311" algn="l">
                <a:lnSpc>
                  <a:spcPts val="2520"/>
                </a:lnSpc>
                <a:buFont typeface="Arial"/>
                <a:buChar char="•"/>
              </a:pPr>
              <a:r>
                <a:rPr lang="en-US" sz="180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Living in more deprived areas </a:t>
              </a:r>
            </a:p>
            <a:p>
              <a:pPr marL="388622" lvl="1" indent="-194311" algn="l">
                <a:lnSpc>
                  <a:spcPts val="2520"/>
                </a:lnSpc>
                <a:buFont typeface="Arial"/>
                <a:buChar char="•"/>
              </a:pPr>
              <a:r>
                <a:rPr lang="en-US" sz="180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People who currently smoke</a:t>
              </a:r>
            </a:p>
          </p:txBody>
        </p:sp>
        <p:grpSp>
          <p:nvGrpSpPr>
            <p:cNvPr id="39" name="Group 39"/>
            <p:cNvGrpSpPr/>
            <p:nvPr/>
          </p:nvGrpSpPr>
          <p:grpSpPr>
            <a:xfrm>
              <a:off x="13929631" y="1244995"/>
              <a:ext cx="2303780" cy="2303849"/>
              <a:chOff x="0" y="0"/>
              <a:chExt cx="746205" cy="746228"/>
            </a:xfrm>
          </p:grpSpPr>
          <p:sp>
            <p:nvSpPr>
              <p:cNvPr id="40" name="Freeform 40"/>
              <p:cNvSpPr/>
              <p:nvPr/>
            </p:nvSpPr>
            <p:spPr>
              <a:xfrm>
                <a:off x="0" y="0"/>
                <a:ext cx="746205" cy="746228"/>
              </a:xfrm>
              <a:custGeom>
                <a:avLst/>
                <a:gdLst/>
                <a:ahLst/>
                <a:cxnLst/>
                <a:rect l="l" t="t" r="r" b="b"/>
                <a:pathLst>
                  <a:path w="746205" h="746228">
                    <a:moveTo>
                      <a:pt x="373103" y="0"/>
                    </a:moveTo>
                    <a:cubicBezTo>
                      <a:pt x="167044" y="0"/>
                      <a:pt x="0" y="167049"/>
                      <a:pt x="0" y="373114"/>
                    </a:cubicBezTo>
                    <a:cubicBezTo>
                      <a:pt x="0" y="579179"/>
                      <a:pt x="167044" y="746228"/>
                      <a:pt x="373103" y="746228"/>
                    </a:cubicBezTo>
                    <a:cubicBezTo>
                      <a:pt x="579162" y="746228"/>
                      <a:pt x="746205" y="579179"/>
                      <a:pt x="746205" y="373114"/>
                    </a:cubicBezTo>
                    <a:cubicBezTo>
                      <a:pt x="746205" y="167049"/>
                      <a:pt x="579162" y="0"/>
                      <a:pt x="373103" y="0"/>
                    </a:cubicBezTo>
                    <a:close/>
                  </a:path>
                </a:pathLst>
              </a:custGeom>
              <a:solidFill>
                <a:srgbClr val="FFBF42">
                  <a:alpha val="84706"/>
                </a:srgbClr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1" name="TextBox 41"/>
              <p:cNvSpPr txBox="1"/>
              <p:nvPr/>
            </p:nvSpPr>
            <p:spPr>
              <a:xfrm>
                <a:off x="69957" y="22334"/>
                <a:ext cx="606292" cy="65393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endParaRPr/>
              </a:p>
            </p:txBody>
          </p:sp>
        </p:grpSp>
        <p:sp>
          <p:nvSpPr>
            <p:cNvPr id="42" name="TextBox 42"/>
            <p:cNvSpPr txBox="1"/>
            <p:nvPr/>
          </p:nvSpPr>
          <p:spPr>
            <a:xfrm>
              <a:off x="14064901" y="1678312"/>
              <a:ext cx="2033241" cy="138959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ctr">
                <a:lnSpc>
                  <a:spcPts val="2800"/>
                </a:lnSpc>
                <a:spcBef>
                  <a:spcPct val="0"/>
                </a:spcBef>
              </a:pPr>
              <a:r>
                <a:rPr lang="en-US" sz="1900" dirty="0">
                  <a:solidFill>
                    <a:srgbClr val="000000"/>
                  </a:solidFill>
                  <a:latin typeface="Canva Sans"/>
                  <a:ea typeface="Canva Sans"/>
                  <a:cs typeface="Canva Sans"/>
                  <a:sym typeface="Canva Sans"/>
                </a:rPr>
                <a:t>24,400 reminders sent</a:t>
              </a:r>
            </a:p>
          </p:txBody>
        </p:sp>
        <p:sp>
          <p:nvSpPr>
            <p:cNvPr id="43" name="Freeform 43"/>
            <p:cNvSpPr/>
            <p:nvPr/>
          </p:nvSpPr>
          <p:spPr>
            <a:xfrm>
              <a:off x="0" y="30480"/>
              <a:ext cx="6543040" cy="7650480"/>
            </a:xfrm>
            <a:custGeom>
              <a:avLst/>
              <a:gdLst/>
              <a:ahLst/>
              <a:cxnLst/>
              <a:rect l="l" t="t" r="r" b="b"/>
              <a:pathLst>
                <a:path w="6543040" h="7650480">
                  <a:moveTo>
                    <a:pt x="0" y="0"/>
                  </a:moveTo>
                  <a:lnTo>
                    <a:pt x="6543040" y="0"/>
                  </a:lnTo>
                  <a:lnTo>
                    <a:pt x="6543040" y="7650480"/>
                  </a:lnTo>
                  <a:lnTo>
                    <a:pt x="0" y="7650480"/>
                  </a:lnTo>
                  <a:lnTo>
                    <a:pt x="0" y="0"/>
                  </a:lnTo>
                  <a:close/>
                </a:path>
              </a:pathLst>
            </a:custGeom>
            <a:blipFill>
              <a:blip r:embed="rId6"/>
              <a:stretch>
                <a:fillRect t="-9980" b="-10683"/>
              </a:stretch>
            </a:blipFill>
          </p:spPr>
          <p:txBody>
            <a:bodyPr/>
            <a:lstStyle/>
            <a:p>
              <a:endParaRPr lang="en-US"/>
            </a:p>
          </p:txBody>
        </p:sp>
        <p:grpSp>
          <p:nvGrpSpPr>
            <p:cNvPr id="44" name="Group 44"/>
            <p:cNvGrpSpPr/>
            <p:nvPr/>
          </p:nvGrpSpPr>
          <p:grpSpPr>
            <a:xfrm>
              <a:off x="64406" y="1166876"/>
              <a:ext cx="6414228" cy="1561730"/>
              <a:chOff x="0" y="0"/>
              <a:chExt cx="1520410" cy="370188"/>
            </a:xfrm>
          </p:grpSpPr>
          <p:sp>
            <p:nvSpPr>
              <p:cNvPr id="45" name="Freeform 45"/>
              <p:cNvSpPr/>
              <p:nvPr/>
            </p:nvSpPr>
            <p:spPr>
              <a:xfrm>
                <a:off x="0" y="0"/>
                <a:ext cx="1520410" cy="370188"/>
              </a:xfrm>
              <a:custGeom>
                <a:avLst/>
                <a:gdLst/>
                <a:ahLst/>
                <a:cxnLst/>
                <a:rect l="l" t="t" r="r" b="b"/>
                <a:pathLst>
                  <a:path w="1520410" h="370188">
                    <a:moveTo>
                      <a:pt x="67592" y="0"/>
                    </a:moveTo>
                    <a:lnTo>
                      <a:pt x="1452818" y="0"/>
                    </a:lnTo>
                    <a:cubicBezTo>
                      <a:pt x="1470744" y="0"/>
                      <a:pt x="1487937" y="7121"/>
                      <a:pt x="1500612" y="19797"/>
                    </a:cubicBezTo>
                    <a:cubicBezTo>
                      <a:pt x="1513288" y="32473"/>
                      <a:pt x="1520410" y="49665"/>
                      <a:pt x="1520410" y="67592"/>
                    </a:cubicBezTo>
                    <a:lnTo>
                      <a:pt x="1520410" y="302596"/>
                    </a:lnTo>
                    <a:cubicBezTo>
                      <a:pt x="1520410" y="320523"/>
                      <a:pt x="1513288" y="337715"/>
                      <a:pt x="1500612" y="350391"/>
                    </a:cubicBezTo>
                    <a:cubicBezTo>
                      <a:pt x="1487937" y="363067"/>
                      <a:pt x="1470744" y="370188"/>
                      <a:pt x="1452818" y="370188"/>
                    </a:cubicBezTo>
                    <a:lnTo>
                      <a:pt x="67592" y="370188"/>
                    </a:lnTo>
                    <a:cubicBezTo>
                      <a:pt x="49665" y="370188"/>
                      <a:pt x="32473" y="363067"/>
                      <a:pt x="19797" y="350391"/>
                    </a:cubicBezTo>
                    <a:cubicBezTo>
                      <a:pt x="7121" y="337715"/>
                      <a:pt x="0" y="320523"/>
                      <a:pt x="0" y="302596"/>
                    </a:cubicBezTo>
                    <a:lnTo>
                      <a:pt x="0" y="67592"/>
                    </a:lnTo>
                    <a:cubicBezTo>
                      <a:pt x="0" y="49665"/>
                      <a:pt x="7121" y="32473"/>
                      <a:pt x="19797" y="19797"/>
                    </a:cubicBezTo>
                    <a:cubicBezTo>
                      <a:pt x="32473" y="7121"/>
                      <a:pt x="49665" y="0"/>
                      <a:pt x="67592" y="0"/>
                    </a:cubicBezTo>
                    <a:close/>
                  </a:path>
                </a:pathLst>
              </a:custGeom>
              <a:solidFill>
                <a:srgbClr val="EDEDED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6" name="TextBox 46"/>
              <p:cNvSpPr txBox="1"/>
              <p:nvPr/>
            </p:nvSpPr>
            <p:spPr>
              <a:xfrm>
                <a:off x="0" y="-9525"/>
                <a:ext cx="1520410" cy="379713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400"/>
                  </a:lnSpc>
                </a:pPr>
                <a:r>
                  <a:rPr lang="en-US" sz="2000" u="sng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LSUT</a:t>
                </a:r>
              </a:p>
              <a:p>
                <a:pPr algn="ctr">
                  <a:lnSpc>
                    <a:spcPts val="2660"/>
                  </a:lnSpc>
                </a:pPr>
                <a:r>
                  <a:rPr lang="en-US" sz="190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Initial timed appointments: 40.3%</a:t>
                </a:r>
              </a:p>
              <a:p>
                <a:pPr algn="ctr">
                  <a:lnSpc>
                    <a:spcPts val="2660"/>
                  </a:lnSpc>
                </a:pPr>
                <a:r>
                  <a:rPr lang="en-US" sz="190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Overall (with reminders): 52.6% </a:t>
                </a:r>
              </a:p>
            </p:txBody>
          </p:sp>
        </p:grpSp>
        <p:grpSp>
          <p:nvGrpSpPr>
            <p:cNvPr id="47" name="Group 47"/>
            <p:cNvGrpSpPr/>
            <p:nvPr/>
          </p:nvGrpSpPr>
          <p:grpSpPr>
            <a:xfrm>
              <a:off x="64135" y="4420983"/>
              <a:ext cx="6414770" cy="1565910"/>
              <a:chOff x="0" y="0"/>
              <a:chExt cx="1520538" cy="371179"/>
            </a:xfrm>
          </p:grpSpPr>
          <p:sp>
            <p:nvSpPr>
              <p:cNvPr id="48" name="Freeform 48"/>
              <p:cNvSpPr/>
              <p:nvPr/>
            </p:nvSpPr>
            <p:spPr>
              <a:xfrm>
                <a:off x="0" y="0"/>
                <a:ext cx="1520538" cy="371179"/>
              </a:xfrm>
              <a:custGeom>
                <a:avLst/>
                <a:gdLst/>
                <a:ahLst/>
                <a:cxnLst/>
                <a:rect l="l" t="t" r="r" b="b"/>
                <a:pathLst>
                  <a:path w="1520538" h="371179">
                    <a:moveTo>
                      <a:pt x="67586" y="0"/>
                    </a:moveTo>
                    <a:lnTo>
                      <a:pt x="1452952" y="0"/>
                    </a:lnTo>
                    <a:cubicBezTo>
                      <a:pt x="1490279" y="0"/>
                      <a:pt x="1520538" y="30259"/>
                      <a:pt x="1520538" y="67586"/>
                    </a:cubicBezTo>
                    <a:lnTo>
                      <a:pt x="1520538" y="303593"/>
                    </a:lnTo>
                    <a:cubicBezTo>
                      <a:pt x="1520538" y="321518"/>
                      <a:pt x="1513418" y="338708"/>
                      <a:pt x="1500743" y="351383"/>
                    </a:cubicBezTo>
                    <a:cubicBezTo>
                      <a:pt x="1488068" y="364058"/>
                      <a:pt x="1470877" y="371179"/>
                      <a:pt x="1452952" y="371179"/>
                    </a:cubicBezTo>
                    <a:lnTo>
                      <a:pt x="67586" y="371179"/>
                    </a:lnTo>
                    <a:cubicBezTo>
                      <a:pt x="49661" y="371179"/>
                      <a:pt x="32470" y="364058"/>
                      <a:pt x="19795" y="351383"/>
                    </a:cubicBezTo>
                    <a:cubicBezTo>
                      <a:pt x="7121" y="338708"/>
                      <a:pt x="0" y="321518"/>
                      <a:pt x="0" y="303593"/>
                    </a:cubicBezTo>
                    <a:lnTo>
                      <a:pt x="0" y="67586"/>
                    </a:lnTo>
                    <a:cubicBezTo>
                      <a:pt x="0" y="49661"/>
                      <a:pt x="7121" y="32470"/>
                      <a:pt x="19795" y="19795"/>
                    </a:cubicBezTo>
                    <a:cubicBezTo>
                      <a:pt x="32470" y="7121"/>
                      <a:pt x="49661" y="0"/>
                      <a:pt x="67586" y="0"/>
                    </a:cubicBezTo>
                    <a:close/>
                  </a:path>
                </a:pathLst>
              </a:custGeom>
              <a:solidFill>
                <a:srgbClr val="EDEDED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9" name="TextBox 49"/>
              <p:cNvSpPr txBox="1"/>
              <p:nvPr/>
            </p:nvSpPr>
            <p:spPr>
              <a:xfrm>
                <a:off x="0" y="-47625"/>
                <a:ext cx="1520538" cy="418804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r>
                  <a:rPr lang="en-US" sz="2000" u="sng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YLST</a:t>
                </a:r>
              </a:p>
              <a:p>
                <a:pPr algn="ctr">
                  <a:lnSpc>
                    <a:spcPts val="2660"/>
                  </a:lnSpc>
                </a:pPr>
                <a:r>
                  <a:rPr lang="en-US" sz="190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Initial open invitations: 28.0%</a:t>
                </a:r>
              </a:p>
              <a:p>
                <a:pPr algn="ctr">
                  <a:lnSpc>
                    <a:spcPts val="2660"/>
                  </a:lnSpc>
                </a:pPr>
                <a:r>
                  <a:rPr lang="en-US" sz="190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Overall (with reminders): 50.8%</a:t>
                </a:r>
              </a:p>
            </p:txBody>
          </p:sp>
        </p:grpSp>
        <p:grpSp>
          <p:nvGrpSpPr>
            <p:cNvPr id="50" name="Group 50"/>
            <p:cNvGrpSpPr/>
            <p:nvPr/>
          </p:nvGrpSpPr>
          <p:grpSpPr>
            <a:xfrm>
              <a:off x="0" y="30480"/>
              <a:ext cx="6543040" cy="1047496"/>
              <a:chOff x="0" y="0"/>
              <a:chExt cx="1550943" cy="248295"/>
            </a:xfrm>
          </p:grpSpPr>
          <p:sp>
            <p:nvSpPr>
              <p:cNvPr id="51" name="Freeform 51"/>
              <p:cNvSpPr/>
              <p:nvPr/>
            </p:nvSpPr>
            <p:spPr>
              <a:xfrm>
                <a:off x="0" y="0"/>
                <a:ext cx="1550943" cy="248295"/>
              </a:xfrm>
              <a:custGeom>
                <a:avLst/>
                <a:gdLst/>
                <a:ahLst/>
                <a:cxnLst/>
                <a:rect l="l" t="t" r="r" b="b"/>
                <a:pathLst>
                  <a:path w="1550943" h="248295">
                    <a:moveTo>
                      <a:pt x="0" y="0"/>
                    </a:moveTo>
                    <a:lnTo>
                      <a:pt x="1550943" y="0"/>
                    </a:lnTo>
                    <a:lnTo>
                      <a:pt x="1550943" y="248295"/>
                    </a:lnTo>
                    <a:lnTo>
                      <a:pt x="0" y="248295"/>
                    </a:lnTo>
                    <a:close/>
                  </a:path>
                </a:pathLst>
              </a:custGeom>
              <a:solidFill>
                <a:srgbClr val="00B0F0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2" name="TextBox 52"/>
              <p:cNvSpPr txBox="1"/>
              <p:nvPr/>
            </p:nvSpPr>
            <p:spPr>
              <a:xfrm>
                <a:off x="0" y="38100"/>
                <a:ext cx="1550943" cy="21019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200"/>
                  </a:lnSpc>
                </a:pPr>
                <a:r>
                  <a:rPr lang="en-US" sz="2200" b="1">
                    <a:solidFill>
                      <a:srgbClr val="FFFFFF"/>
                    </a:solidFill>
                    <a:latin typeface="Canva Sans Bold"/>
                    <a:ea typeface="Canva Sans Bold"/>
                    <a:cs typeface="Canva Sans Bold"/>
                    <a:sym typeface="Canva Sans Bold"/>
                  </a:rPr>
                  <a:t>Uptake in lung cancer screening trials to date</a:t>
                </a:r>
              </a:p>
            </p:txBody>
          </p:sp>
        </p:grpSp>
        <p:grpSp>
          <p:nvGrpSpPr>
            <p:cNvPr id="53" name="Group 53"/>
            <p:cNvGrpSpPr/>
            <p:nvPr/>
          </p:nvGrpSpPr>
          <p:grpSpPr>
            <a:xfrm>
              <a:off x="64135" y="2791839"/>
              <a:ext cx="6414770" cy="1565910"/>
              <a:chOff x="0" y="0"/>
              <a:chExt cx="1520538" cy="371179"/>
            </a:xfrm>
          </p:grpSpPr>
          <p:sp>
            <p:nvSpPr>
              <p:cNvPr id="54" name="Freeform 54"/>
              <p:cNvSpPr/>
              <p:nvPr/>
            </p:nvSpPr>
            <p:spPr>
              <a:xfrm>
                <a:off x="0" y="0"/>
                <a:ext cx="1520538" cy="371179"/>
              </a:xfrm>
              <a:custGeom>
                <a:avLst/>
                <a:gdLst/>
                <a:ahLst/>
                <a:cxnLst/>
                <a:rect l="l" t="t" r="r" b="b"/>
                <a:pathLst>
                  <a:path w="1520538" h="371179">
                    <a:moveTo>
                      <a:pt x="67586" y="0"/>
                    </a:moveTo>
                    <a:lnTo>
                      <a:pt x="1452952" y="0"/>
                    </a:lnTo>
                    <a:cubicBezTo>
                      <a:pt x="1490279" y="0"/>
                      <a:pt x="1520538" y="30259"/>
                      <a:pt x="1520538" y="67586"/>
                    </a:cubicBezTo>
                    <a:lnTo>
                      <a:pt x="1520538" y="303593"/>
                    </a:lnTo>
                    <a:cubicBezTo>
                      <a:pt x="1520538" y="321518"/>
                      <a:pt x="1513418" y="338708"/>
                      <a:pt x="1500743" y="351383"/>
                    </a:cubicBezTo>
                    <a:cubicBezTo>
                      <a:pt x="1488068" y="364058"/>
                      <a:pt x="1470877" y="371179"/>
                      <a:pt x="1452952" y="371179"/>
                    </a:cubicBezTo>
                    <a:lnTo>
                      <a:pt x="67586" y="371179"/>
                    </a:lnTo>
                    <a:cubicBezTo>
                      <a:pt x="49661" y="371179"/>
                      <a:pt x="32470" y="364058"/>
                      <a:pt x="19795" y="351383"/>
                    </a:cubicBezTo>
                    <a:cubicBezTo>
                      <a:pt x="7121" y="338708"/>
                      <a:pt x="0" y="321518"/>
                      <a:pt x="0" y="303593"/>
                    </a:cubicBezTo>
                    <a:lnTo>
                      <a:pt x="0" y="67586"/>
                    </a:lnTo>
                    <a:cubicBezTo>
                      <a:pt x="0" y="49661"/>
                      <a:pt x="7121" y="32470"/>
                      <a:pt x="19795" y="19795"/>
                    </a:cubicBezTo>
                    <a:cubicBezTo>
                      <a:pt x="32470" y="7121"/>
                      <a:pt x="49661" y="0"/>
                      <a:pt x="67586" y="0"/>
                    </a:cubicBezTo>
                    <a:close/>
                  </a:path>
                </a:pathLst>
              </a:custGeom>
              <a:solidFill>
                <a:srgbClr val="EDEDED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5" name="TextBox 55"/>
              <p:cNvSpPr txBox="1"/>
              <p:nvPr/>
            </p:nvSpPr>
            <p:spPr>
              <a:xfrm>
                <a:off x="0" y="-47625"/>
                <a:ext cx="1520538" cy="418804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r>
                  <a:rPr lang="en-US" sz="2000" u="sng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SUMMIT</a:t>
                </a:r>
              </a:p>
              <a:p>
                <a:pPr algn="ctr">
                  <a:lnSpc>
                    <a:spcPts val="2660"/>
                  </a:lnSpc>
                </a:pPr>
                <a:r>
                  <a:rPr lang="en-US" sz="190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Initial open invitations: 31.0% </a:t>
                </a:r>
              </a:p>
              <a:p>
                <a:pPr algn="ctr">
                  <a:lnSpc>
                    <a:spcPts val="2660"/>
                  </a:lnSpc>
                </a:pPr>
                <a:r>
                  <a:rPr lang="en-US" sz="190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Responded to reminder: 14.0%</a:t>
                </a:r>
              </a:p>
            </p:txBody>
          </p:sp>
        </p:grpSp>
        <p:grpSp>
          <p:nvGrpSpPr>
            <p:cNvPr id="56" name="Group 56"/>
            <p:cNvGrpSpPr/>
            <p:nvPr/>
          </p:nvGrpSpPr>
          <p:grpSpPr>
            <a:xfrm>
              <a:off x="64135" y="6050126"/>
              <a:ext cx="6414770" cy="1565910"/>
              <a:chOff x="0" y="0"/>
              <a:chExt cx="1520538" cy="371179"/>
            </a:xfrm>
          </p:grpSpPr>
          <p:sp>
            <p:nvSpPr>
              <p:cNvPr id="57" name="Freeform 57"/>
              <p:cNvSpPr/>
              <p:nvPr/>
            </p:nvSpPr>
            <p:spPr>
              <a:xfrm>
                <a:off x="0" y="0"/>
                <a:ext cx="1520538" cy="371179"/>
              </a:xfrm>
              <a:custGeom>
                <a:avLst/>
                <a:gdLst/>
                <a:ahLst/>
                <a:cxnLst/>
                <a:rect l="l" t="t" r="r" b="b"/>
                <a:pathLst>
                  <a:path w="1520538" h="371179">
                    <a:moveTo>
                      <a:pt x="67586" y="0"/>
                    </a:moveTo>
                    <a:lnTo>
                      <a:pt x="1452952" y="0"/>
                    </a:lnTo>
                    <a:cubicBezTo>
                      <a:pt x="1490279" y="0"/>
                      <a:pt x="1520538" y="30259"/>
                      <a:pt x="1520538" y="67586"/>
                    </a:cubicBezTo>
                    <a:lnTo>
                      <a:pt x="1520538" y="303593"/>
                    </a:lnTo>
                    <a:cubicBezTo>
                      <a:pt x="1520538" y="321518"/>
                      <a:pt x="1513418" y="338708"/>
                      <a:pt x="1500743" y="351383"/>
                    </a:cubicBezTo>
                    <a:cubicBezTo>
                      <a:pt x="1488068" y="364058"/>
                      <a:pt x="1470877" y="371179"/>
                      <a:pt x="1452952" y="371179"/>
                    </a:cubicBezTo>
                    <a:lnTo>
                      <a:pt x="67586" y="371179"/>
                    </a:lnTo>
                    <a:cubicBezTo>
                      <a:pt x="49661" y="371179"/>
                      <a:pt x="32470" y="364058"/>
                      <a:pt x="19795" y="351383"/>
                    </a:cubicBezTo>
                    <a:cubicBezTo>
                      <a:pt x="7121" y="338708"/>
                      <a:pt x="0" y="321518"/>
                      <a:pt x="0" y="303593"/>
                    </a:cubicBezTo>
                    <a:lnTo>
                      <a:pt x="0" y="67586"/>
                    </a:lnTo>
                    <a:cubicBezTo>
                      <a:pt x="0" y="49661"/>
                      <a:pt x="7121" y="32470"/>
                      <a:pt x="19795" y="19795"/>
                    </a:cubicBezTo>
                    <a:cubicBezTo>
                      <a:pt x="32470" y="7121"/>
                      <a:pt x="49661" y="0"/>
                      <a:pt x="67586" y="0"/>
                    </a:cubicBezTo>
                    <a:close/>
                  </a:path>
                </a:pathLst>
              </a:custGeom>
              <a:solidFill>
                <a:srgbClr val="EDEDED"/>
              </a:solidFill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8" name="TextBox 58"/>
              <p:cNvSpPr txBox="1"/>
              <p:nvPr/>
            </p:nvSpPr>
            <p:spPr>
              <a:xfrm>
                <a:off x="0" y="-47625"/>
                <a:ext cx="1520538" cy="418804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2800"/>
                  </a:lnSpc>
                </a:pPr>
                <a:r>
                  <a:rPr lang="en-US" sz="2000" u="sng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Manchester Lung Health Check</a:t>
                </a:r>
              </a:p>
              <a:p>
                <a:pPr algn="ctr">
                  <a:lnSpc>
                    <a:spcPts val="2660"/>
                  </a:lnSpc>
                </a:pPr>
                <a:r>
                  <a:rPr lang="en-US" sz="1900">
                    <a:solidFill>
                      <a:srgbClr val="000000"/>
                    </a:solidFill>
                    <a:latin typeface="Canva Sans"/>
                    <a:ea typeface="Canva Sans"/>
                    <a:cs typeface="Canva Sans"/>
                    <a:sym typeface="Canva Sans"/>
                  </a:rPr>
                  <a:t>Initial open invitations: 26.3%</a:t>
                </a: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1</Words>
  <Application>Microsoft Macintosh PowerPoint</Application>
  <PresentationFormat>Custom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nva Sans Bold</vt:lpstr>
      <vt:lpstr>Calibri</vt:lpstr>
      <vt:lpstr>Canva Sans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ptake Thorax Visual Abstract</dc:title>
  <cp:lastModifiedBy>Amyn Bhamani</cp:lastModifiedBy>
  <cp:revision>2</cp:revision>
  <dcterms:created xsi:type="dcterms:W3CDTF">2006-08-16T00:00:00Z</dcterms:created>
  <dcterms:modified xsi:type="dcterms:W3CDTF">2025-01-21T12:55:35Z</dcterms:modified>
  <dc:identifier>DAGcp6jxh9U</dc:identifier>
</cp:coreProperties>
</file>